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7" r:id="rId2"/>
    <p:sldId id="258" r:id="rId3"/>
    <p:sldId id="259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96" autoAdjust="0"/>
    <p:restoredTop sz="94660"/>
  </p:normalViewPr>
  <p:slideViewPr>
    <p:cSldViewPr snapToGrid="0">
      <p:cViewPr varScale="1">
        <p:scale>
          <a:sx n="74" d="100"/>
          <a:sy n="74" d="100"/>
        </p:scale>
        <p:origin x="49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10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1D0D340-6201-448B-8A76-0B18BE93127D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2F7E9B-323D-4ED7-A0AC-7B809035DD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34957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29BB6D5-ACF9-49E1-B238-4AFAA34C97D9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010362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CCE01-CF96-45DB-B0FB-90F6C104EEBA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59A3A-58D9-4091-BD27-C3CF6CCCAD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88949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CCE01-CF96-45DB-B0FB-90F6C104EEBA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59A3A-58D9-4091-BD27-C3CF6CCCAD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65305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CCE01-CF96-45DB-B0FB-90F6C104EEBA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59A3A-58D9-4091-BD27-C3CF6CCCAD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72142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CCE01-CF96-45DB-B0FB-90F6C104EEBA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59A3A-58D9-4091-BD27-C3CF6CCCAD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95954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CCE01-CF96-45DB-B0FB-90F6C104EEBA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59A3A-58D9-4091-BD27-C3CF6CCCAD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64873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CCE01-CF96-45DB-B0FB-90F6C104EEBA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59A3A-58D9-4091-BD27-C3CF6CCCAD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53519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CCE01-CF96-45DB-B0FB-90F6C104EEBA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59A3A-58D9-4091-BD27-C3CF6CCCAD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06889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CCE01-CF96-45DB-B0FB-90F6C104EEBA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59A3A-58D9-4091-BD27-C3CF6CCCAD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40601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CCE01-CF96-45DB-B0FB-90F6C104EEBA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59A3A-58D9-4091-BD27-C3CF6CCCAD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43301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CCE01-CF96-45DB-B0FB-90F6C104EEBA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59A3A-58D9-4091-BD27-C3CF6CCCAD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54848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CCE01-CF96-45DB-B0FB-90F6C104EEBA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59A3A-58D9-4091-BD27-C3CF6CCCAD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40478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CCCE01-CF96-45DB-B0FB-90F6C104EEBA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159A3A-58D9-4091-BD27-C3CF6CCCAD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48162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7500" y="1000170"/>
            <a:ext cx="2675440" cy="2926080"/>
          </a:xfrm>
          <a:prstGeom prst="rect">
            <a:avLst/>
          </a:prstGeom>
        </p:spPr>
      </p:pic>
      <p:sp>
        <p:nvSpPr>
          <p:cNvPr id="11" name="Rectangle 10"/>
          <p:cNvSpPr/>
          <p:nvPr/>
        </p:nvSpPr>
        <p:spPr>
          <a:xfrm>
            <a:off x="339243" y="947857"/>
            <a:ext cx="468398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000" b="1" dirty="0">
                <a:latin typeface="Arial Black" panose="020B0A04020102020204" pitchFamily="34" charset="0"/>
              </a:rPr>
              <a:t>A.</a:t>
            </a:r>
            <a:endParaRPr lang="en-US" sz="2000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61428" y="1045890"/>
            <a:ext cx="2602196" cy="283464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75290" y="1000170"/>
            <a:ext cx="2686138" cy="2926080"/>
          </a:xfrm>
          <a:prstGeom prst="rect">
            <a:avLst/>
          </a:prstGeom>
        </p:spPr>
      </p:pic>
      <p:sp>
        <p:nvSpPr>
          <p:cNvPr id="10" name="Rectangle 9"/>
          <p:cNvSpPr/>
          <p:nvPr/>
        </p:nvSpPr>
        <p:spPr>
          <a:xfrm>
            <a:off x="3265545" y="947857"/>
            <a:ext cx="472758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000" b="1" dirty="0">
                <a:latin typeface="Arial Black" panose="020B0A04020102020204" pitchFamily="34" charset="0"/>
              </a:rPr>
              <a:t>C.</a:t>
            </a:r>
            <a:endParaRPr lang="en-US" sz="2000" dirty="0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7500" y="3931920"/>
            <a:ext cx="2675440" cy="2926080"/>
          </a:xfrm>
          <a:prstGeom prst="rect">
            <a:avLst/>
          </a:prstGeom>
        </p:spPr>
      </p:pic>
      <p:sp>
        <p:nvSpPr>
          <p:cNvPr id="14" name="Rectangle 13"/>
          <p:cNvSpPr/>
          <p:nvPr/>
        </p:nvSpPr>
        <p:spPr>
          <a:xfrm>
            <a:off x="347363" y="3942691"/>
            <a:ext cx="472502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000" b="1" dirty="0">
                <a:latin typeface="Arial Black" panose="020B0A04020102020204" pitchFamily="34" charset="0"/>
              </a:rPr>
              <a:t>B.</a:t>
            </a:r>
            <a:endParaRPr lang="en-US" sz="2000" dirty="0"/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75290" y="3920581"/>
            <a:ext cx="2686138" cy="2926080"/>
          </a:xfrm>
          <a:prstGeom prst="rect">
            <a:avLst/>
          </a:prstGeom>
        </p:spPr>
      </p:pic>
      <p:sp>
        <p:nvSpPr>
          <p:cNvPr id="15" name="Rectangle 14"/>
          <p:cNvSpPr/>
          <p:nvPr/>
        </p:nvSpPr>
        <p:spPr>
          <a:xfrm>
            <a:off x="3253674" y="3942691"/>
            <a:ext cx="464038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000" b="1" dirty="0">
                <a:latin typeface="Arial Black" panose="020B0A04020102020204" pitchFamily="34" charset="0"/>
              </a:rPr>
              <a:t>D.</a:t>
            </a:r>
            <a:endParaRPr lang="en-US" sz="2000" dirty="0"/>
          </a:p>
        </p:txBody>
      </p:sp>
      <p:sp>
        <p:nvSpPr>
          <p:cNvPr id="16" name="Rectangle 15"/>
          <p:cNvSpPr/>
          <p:nvPr/>
        </p:nvSpPr>
        <p:spPr>
          <a:xfrm>
            <a:off x="5843778" y="947857"/>
            <a:ext cx="455574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000" b="1" dirty="0">
                <a:latin typeface="Arial Black" panose="020B0A04020102020204" pitchFamily="34" charset="0"/>
              </a:rPr>
              <a:t>E.</a:t>
            </a:r>
            <a:endParaRPr lang="en-US" sz="2000" dirty="0"/>
          </a:p>
        </p:txBody>
      </p:sp>
    </p:spTree>
    <p:extLst>
      <p:ext uri="{BB962C8B-B14F-4D97-AF65-F5344CB8AC3E}">
        <p14:creationId xmlns:p14="http://schemas.microsoft.com/office/powerpoint/2010/main" val="1431101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85B3E860-F5C4-4FA8-B107-72D39C2995A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70999" y="1298368"/>
            <a:ext cx="5850001" cy="42612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5452070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618185" y="463638"/>
            <a:ext cx="10934163" cy="187051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b="1" u="sng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1.</a:t>
            </a:r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Reproducibility of </a:t>
            </a:r>
            <a:r>
              <a:rPr lang="en-US" b="1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ccDNA</a:t>
            </a:r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enrichment. (A – E) 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lots showing log</a:t>
            </a:r>
            <a:r>
              <a:rPr lang="en-US" baseline="-25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0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of read coverage for each chromosome with a bin size of 1000 </a:t>
            </a:r>
            <a:r>
              <a:rPr lang="en-US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p.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tDNA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is shown in blue. </a:t>
            </a:r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A)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compares </a:t>
            </a:r>
            <a:r>
              <a:rPr lang="en-US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ccDNA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enrichment obtained by both methods (GB is the bottom band on a </a:t>
            </a:r>
            <a:r>
              <a:rPr lang="en-US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sCl-EtdBr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gradient and </a:t>
            </a:r>
            <a:r>
              <a:rPr lang="en-US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exo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is total genomic DNA; G, treated with </a:t>
            </a:r>
            <a:r>
              <a:rPr lang="en-US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xoV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 </a:t>
            </a:r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B)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compares GB to a </a:t>
            </a:r>
            <a:r>
              <a:rPr lang="en-US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exo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ample purified on a </a:t>
            </a:r>
            <a:r>
              <a:rPr lang="en-US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sCl-EtdBr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gradient. </a:t>
            </a:r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C)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and </a:t>
            </a:r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D)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show data obtained for technical and biological replicates respectively. </a:t>
            </a:r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E)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shows the difference in coverage of total genomic DNA, G, in comparison to </a:t>
            </a:r>
            <a:r>
              <a:rPr lang="en-US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ccDNAs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from the same sample, </a:t>
            </a:r>
            <a:r>
              <a:rPr lang="en-US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exo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 </a:t>
            </a:r>
            <a:endParaRPr lang="en-US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012785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4</Words>
  <Application>Microsoft Office PowerPoint</Application>
  <PresentationFormat>Widescreen</PresentationFormat>
  <Paragraphs>7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Arial</vt:lpstr>
      <vt:lpstr>Arial Black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ssa Shoura</dc:creator>
  <cp:lastModifiedBy>Sarah Wolper</cp:lastModifiedBy>
  <cp:revision>5</cp:revision>
  <dcterms:created xsi:type="dcterms:W3CDTF">2016-12-16T05:02:57Z</dcterms:created>
  <dcterms:modified xsi:type="dcterms:W3CDTF">2017-08-11T11:19:20Z</dcterms:modified>
</cp:coreProperties>
</file>